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3"/>
  </p:notesMasterIdLst>
  <p:sldIdLst>
    <p:sldId id="268" r:id="rId2"/>
  </p:sldIdLst>
  <p:sldSz cx="6116638" cy="57610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0" d="100"/>
          <a:sy n="80" d="100"/>
        </p:scale>
        <p:origin x="1664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2C8F1F3-EA32-44B0-9EC3-E449B29DCC93}" type="datetimeFigureOut">
              <a:rPr lang="en-US" smtClean="0"/>
              <a:t>1/21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792288" y="1143000"/>
            <a:ext cx="3273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8D78E5B-A390-4399-907A-3EF67622FD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3643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790700" y="1143000"/>
            <a:ext cx="32766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. S3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CR results for the verification of gene integration at 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rsB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A) and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acZ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B) gene loci.  RzI_RJ1, RzI_33, RzII_RJ1, RzII_33, EGFP-hDHFR_RJ1, EGFP-hDHFR_33, RSETC_RJ1, RSETC_33, glmS_RJ1, glmS_33, M9_RJ1, and M9_33 are abbreviations of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panose="05050102010706020507" pitchFamily="18" charset="2"/>
              </a:rPr>
              <a:t>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rsB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: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zIEGFP-hDHFR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panose="05050102010706020507" pitchFamily="18" charset="2"/>
              </a:rPr>
              <a:t>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acZ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:RJ1,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panose="05050102010706020507" pitchFamily="18" charset="2"/>
              </a:rPr>
              <a:t>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rsB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: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zIEGFP-hDHFR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panose="05050102010706020507" pitchFamily="18" charset="2"/>
              </a:rPr>
              <a:t>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acZ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:33,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panose="05050102010706020507" pitchFamily="18" charset="2"/>
              </a:rPr>
              <a:t>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rsB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: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zIIEGFP-hDHFR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panose="05050102010706020507" pitchFamily="18" charset="2"/>
              </a:rPr>
              <a:t>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acZ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:RJ1,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panose="05050102010706020507" pitchFamily="18" charset="2"/>
              </a:rPr>
              <a:t>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rsB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: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zIIEGFP-hDHFR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panose="05050102010706020507" pitchFamily="18" charset="2"/>
              </a:rPr>
              <a:t>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acZ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:33,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panose="05050102010706020507" pitchFamily="18" charset="2"/>
              </a:rPr>
              <a:t>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rsB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: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GFP-hDHFR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panose="05050102010706020507" pitchFamily="18" charset="2"/>
              </a:rPr>
              <a:t>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acZ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:RJ1 (EGFP-hDHFR_RJ1),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panose="05050102010706020507" pitchFamily="18" charset="2"/>
              </a:rPr>
              <a:t>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rsB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: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GFP-hDHFR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panose="05050102010706020507" pitchFamily="18" charset="2"/>
              </a:rPr>
              <a:t>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acZ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:33 (EGFP-hDHFR_33),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panose="05050102010706020507" pitchFamily="18" charset="2"/>
              </a:rPr>
              <a:t>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rsB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: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SETC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panose="05050102010706020507" pitchFamily="18" charset="2"/>
              </a:rPr>
              <a:t>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acZ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:RJ1 (RSETC_RJ1),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panose="05050102010706020507" pitchFamily="18" charset="2"/>
              </a:rPr>
              <a:t>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rsB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: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SETC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panose="05050102010706020507" pitchFamily="18" charset="2"/>
              </a:rPr>
              <a:t>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acZ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:33 (RSETC_33),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panose="05050102010706020507" pitchFamily="18" charset="2"/>
              </a:rPr>
              <a:t>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rsB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: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lmS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GFP-hDHFR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panose="05050102010706020507" pitchFamily="18" charset="2"/>
              </a:rPr>
              <a:t>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acZ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:RJ1 (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lm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_RJ1),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panose="05050102010706020507" pitchFamily="18" charset="2"/>
              </a:rPr>
              <a:t>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rsB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: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lmS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GFP-hDHFR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panose="05050102010706020507" pitchFamily="18" charset="2"/>
              </a:rPr>
              <a:t>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acZ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:33 (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lm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_33),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panose="05050102010706020507" pitchFamily="18" charset="2"/>
              </a:rPr>
              <a:t>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rsB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:M9EGFP-hDHFR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panose="05050102010706020507" pitchFamily="18" charset="2"/>
              </a:rPr>
              <a:t>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acZ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:RJ1 (M9_RJ1),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panose="05050102010706020507" pitchFamily="18" charset="2"/>
              </a:rPr>
              <a:t>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rsB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:M9EGFP-hDHFR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panose="05050102010706020507" pitchFamily="18" charset="2"/>
              </a:rPr>
              <a:t>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acZ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:33 (M9_33), respectively. gDNA from wild-type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. coli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BL21(DE3) was used as a negative control in (A) and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panose="05050102010706020507" pitchFamily="18" charset="2"/>
              </a:rPr>
              <a:t>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rsB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: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zIEGFP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hDHFR (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zI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ingle integrant) in (B). PCR products were separated in 0.8% agarose gel and stained with ethidium bromide. M indicates Gene ruler 1kb Plus DNA Ladder (Thermo Scientific, USA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7E1B98D-8478-4045-BA85-74402EC1C33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03748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748" y="942838"/>
            <a:ext cx="5199142" cy="2005695"/>
          </a:xfrm>
        </p:spPr>
        <p:txBody>
          <a:bodyPr anchor="b"/>
          <a:lstStyle>
            <a:lvl1pPr algn="ctr">
              <a:defRPr sz="401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582" y="3025880"/>
            <a:ext cx="4587479" cy="1390917"/>
          </a:xfrm>
        </p:spPr>
        <p:txBody>
          <a:bodyPr/>
          <a:lstStyle>
            <a:lvl1pPr marL="0" indent="0" algn="ctr">
              <a:buNone/>
              <a:defRPr sz="1605"/>
            </a:lvl1pPr>
            <a:lvl2pPr marL="305821" indent="0" algn="ctr">
              <a:buNone/>
              <a:defRPr sz="1338"/>
            </a:lvl2pPr>
            <a:lvl3pPr marL="611642" indent="0" algn="ctr">
              <a:buNone/>
              <a:defRPr sz="1204"/>
            </a:lvl3pPr>
            <a:lvl4pPr marL="917463" indent="0" algn="ctr">
              <a:buNone/>
              <a:defRPr sz="1070"/>
            </a:lvl4pPr>
            <a:lvl5pPr marL="1223284" indent="0" algn="ctr">
              <a:buNone/>
              <a:defRPr sz="1070"/>
            </a:lvl5pPr>
            <a:lvl6pPr marL="1529105" indent="0" algn="ctr">
              <a:buNone/>
              <a:defRPr sz="1070"/>
            </a:lvl6pPr>
            <a:lvl7pPr marL="1834926" indent="0" algn="ctr">
              <a:buNone/>
              <a:defRPr sz="1070"/>
            </a:lvl7pPr>
            <a:lvl8pPr marL="2140748" indent="0" algn="ctr">
              <a:buNone/>
              <a:defRPr sz="1070"/>
            </a:lvl8pPr>
            <a:lvl9pPr marL="2446569" indent="0" algn="ctr">
              <a:buNone/>
              <a:defRPr sz="107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3E62B-8402-4708-B816-52C74535AA18}" type="datetimeFigureOut">
              <a:rPr lang="en-US" smtClean="0"/>
              <a:t>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20EA1-6DEE-4083-A547-33133D4F6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21008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3E62B-8402-4708-B816-52C74535AA18}" type="datetimeFigureOut">
              <a:rPr lang="en-US" smtClean="0"/>
              <a:t>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20EA1-6DEE-4083-A547-33133D4F6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2931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7219" y="306722"/>
            <a:ext cx="1318900" cy="488221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519" y="306722"/>
            <a:ext cx="3880242" cy="4882213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3E62B-8402-4708-B816-52C74535AA18}" type="datetimeFigureOut">
              <a:rPr lang="en-US" smtClean="0"/>
              <a:t>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20EA1-6DEE-4083-A547-33133D4F6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51732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3E62B-8402-4708-B816-52C74535AA18}" type="datetimeFigureOut">
              <a:rPr lang="en-US" smtClean="0"/>
              <a:t>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20EA1-6DEE-4083-A547-33133D4F6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06135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334" y="1436262"/>
            <a:ext cx="5275600" cy="2396431"/>
          </a:xfrm>
        </p:spPr>
        <p:txBody>
          <a:bodyPr anchor="b"/>
          <a:lstStyle>
            <a:lvl1pPr>
              <a:defRPr sz="401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334" y="3855363"/>
            <a:ext cx="5275600" cy="1260227"/>
          </a:xfrm>
        </p:spPr>
        <p:txBody>
          <a:bodyPr/>
          <a:lstStyle>
            <a:lvl1pPr marL="0" indent="0">
              <a:buNone/>
              <a:defRPr sz="1605">
                <a:solidFill>
                  <a:schemeClr val="tx1"/>
                </a:solidFill>
              </a:defRPr>
            </a:lvl1pPr>
            <a:lvl2pPr marL="305821" indent="0">
              <a:buNone/>
              <a:defRPr sz="1338">
                <a:solidFill>
                  <a:schemeClr val="tx1">
                    <a:tint val="75000"/>
                  </a:schemeClr>
                </a:solidFill>
              </a:defRPr>
            </a:lvl2pPr>
            <a:lvl3pPr marL="611642" indent="0">
              <a:buNone/>
              <a:defRPr sz="1204">
                <a:solidFill>
                  <a:schemeClr val="tx1">
                    <a:tint val="75000"/>
                  </a:schemeClr>
                </a:solidFill>
              </a:defRPr>
            </a:lvl3pPr>
            <a:lvl4pPr marL="917463" indent="0">
              <a:buNone/>
              <a:defRPr sz="1070">
                <a:solidFill>
                  <a:schemeClr val="tx1">
                    <a:tint val="75000"/>
                  </a:schemeClr>
                </a:solidFill>
              </a:defRPr>
            </a:lvl4pPr>
            <a:lvl5pPr marL="1223284" indent="0">
              <a:buNone/>
              <a:defRPr sz="1070">
                <a:solidFill>
                  <a:schemeClr val="tx1">
                    <a:tint val="75000"/>
                  </a:schemeClr>
                </a:solidFill>
              </a:defRPr>
            </a:lvl5pPr>
            <a:lvl6pPr marL="1529105" indent="0">
              <a:buNone/>
              <a:defRPr sz="1070">
                <a:solidFill>
                  <a:schemeClr val="tx1">
                    <a:tint val="75000"/>
                  </a:schemeClr>
                </a:solidFill>
              </a:defRPr>
            </a:lvl6pPr>
            <a:lvl7pPr marL="1834926" indent="0">
              <a:buNone/>
              <a:defRPr sz="1070">
                <a:solidFill>
                  <a:schemeClr val="tx1">
                    <a:tint val="75000"/>
                  </a:schemeClr>
                </a:solidFill>
              </a:defRPr>
            </a:lvl7pPr>
            <a:lvl8pPr marL="2140748" indent="0">
              <a:buNone/>
              <a:defRPr sz="1070">
                <a:solidFill>
                  <a:schemeClr val="tx1">
                    <a:tint val="75000"/>
                  </a:schemeClr>
                </a:solidFill>
              </a:defRPr>
            </a:lvl8pPr>
            <a:lvl9pPr marL="2446569" indent="0">
              <a:buNone/>
              <a:defRPr sz="107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3E62B-8402-4708-B816-52C74535AA18}" type="datetimeFigureOut">
              <a:rPr lang="en-US" smtClean="0"/>
              <a:t>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20EA1-6DEE-4083-A547-33133D4F6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61777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520" y="1533609"/>
            <a:ext cx="2599571" cy="365532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6550" y="1533609"/>
            <a:ext cx="2599571" cy="365532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3E62B-8402-4708-B816-52C74535AA18}" type="datetimeFigureOut">
              <a:rPr lang="en-US" smtClean="0"/>
              <a:t>1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20EA1-6DEE-4083-A547-33133D4F6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12969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316" y="306724"/>
            <a:ext cx="5275600" cy="111353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316" y="1412255"/>
            <a:ext cx="2587624" cy="692124"/>
          </a:xfrm>
        </p:spPr>
        <p:txBody>
          <a:bodyPr anchor="b"/>
          <a:lstStyle>
            <a:lvl1pPr marL="0" indent="0">
              <a:buNone/>
              <a:defRPr sz="1605" b="1"/>
            </a:lvl1pPr>
            <a:lvl2pPr marL="305821" indent="0">
              <a:buNone/>
              <a:defRPr sz="1338" b="1"/>
            </a:lvl2pPr>
            <a:lvl3pPr marL="611642" indent="0">
              <a:buNone/>
              <a:defRPr sz="1204" b="1"/>
            </a:lvl3pPr>
            <a:lvl4pPr marL="917463" indent="0">
              <a:buNone/>
              <a:defRPr sz="1070" b="1"/>
            </a:lvl4pPr>
            <a:lvl5pPr marL="1223284" indent="0">
              <a:buNone/>
              <a:defRPr sz="1070" b="1"/>
            </a:lvl5pPr>
            <a:lvl6pPr marL="1529105" indent="0">
              <a:buNone/>
              <a:defRPr sz="1070" b="1"/>
            </a:lvl6pPr>
            <a:lvl7pPr marL="1834926" indent="0">
              <a:buNone/>
              <a:defRPr sz="1070" b="1"/>
            </a:lvl7pPr>
            <a:lvl8pPr marL="2140748" indent="0">
              <a:buNone/>
              <a:defRPr sz="1070" b="1"/>
            </a:lvl8pPr>
            <a:lvl9pPr marL="2446569" indent="0">
              <a:buNone/>
              <a:defRPr sz="107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316" y="2104380"/>
            <a:ext cx="2587624" cy="309522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6548" y="1412255"/>
            <a:ext cx="2600368" cy="692124"/>
          </a:xfrm>
        </p:spPr>
        <p:txBody>
          <a:bodyPr anchor="b"/>
          <a:lstStyle>
            <a:lvl1pPr marL="0" indent="0">
              <a:buNone/>
              <a:defRPr sz="1605" b="1"/>
            </a:lvl1pPr>
            <a:lvl2pPr marL="305821" indent="0">
              <a:buNone/>
              <a:defRPr sz="1338" b="1"/>
            </a:lvl2pPr>
            <a:lvl3pPr marL="611642" indent="0">
              <a:buNone/>
              <a:defRPr sz="1204" b="1"/>
            </a:lvl3pPr>
            <a:lvl4pPr marL="917463" indent="0">
              <a:buNone/>
              <a:defRPr sz="1070" b="1"/>
            </a:lvl4pPr>
            <a:lvl5pPr marL="1223284" indent="0">
              <a:buNone/>
              <a:defRPr sz="1070" b="1"/>
            </a:lvl5pPr>
            <a:lvl6pPr marL="1529105" indent="0">
              <a:buNone/>
              <a:defRPr sz="1070" b="1"/>
            </a:lvl6pPr>
            <a:lvl7pPr marL="1834926" indent="0">
              <a:buNone/>
              <a:defRPr sz="1070" b="1"/>
            </a:lvl7pPr>
            <a:lvl8pPr marL="2140748" indent="0">
              <a:buNone/>
              <a:defRPr sz="1070" b="1"/>
            </a:lvl8pPr>
            <a:lvl9pPr marL="2446569" indent="0">
              <a:buNone/>
              <a:defRPr sz="107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6548" y="2104380"/>
            <a:ext cx="2600368" cy="309522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3E62B-8402-4708-B816-52C74535AA18}" type="datetimeFigureOut">
              <a:rPr lang="en-US" smtClean="0"/>
              <a:t>1/2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20EA1-6DEE-4083-A547-33133D4F6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14401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3E62B-8402-4708-B816-52C74535AA18}" type="datetimeFigureOut">
              <a:rPr lang="en-US" smtClean="0"/>
              <a:t>1/2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20EA1-6DEE-4083-A547-33133D4F6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49682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3E62B-8402-4708-B816-52C74535AA18}" type="datetimeFigureOut">
              <a:rPr lang="en-US" smtClean="0"/>
              <a:t>1/2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20EA1-6DEE-4083-A547-33133D4F6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90351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318" y="384069"/>
            <a:ext cx="1972775" cy="1344242"/>
          </a:xfrm>
        </p:spPr>
        <p:txBody>
          <a:bodyPr anchor="b"/>
          <a:lstStyle>
            <a:lvl1pPr>
              <a:defRPr sz="21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0368" y="829484"/>
            <a:ext cx="3096548" cy="4094071"/>
          </a:xfrm>
        </p:spPr>
        <p:txBody>
          <a:bodyPr/>
          <a:lstStyle>
            <a:lvl1pPr>
              <a:defRPr sz="2140"/>
            </a:lvl1pPr>
            <a:lvl2pPr>
              <a:defRPr sz="1873"/>
            </a:lvl2pPr>
            <a:lvl3pPr>
              <a:defRPr sz="1605"/>
            </a:lvl3pPr>
            <a:lvl4pPr>
              <a:defRPr sz="1338"/>
            </a:lvl4pPr>
            <a:lvl5pPr>
              <a:defRPr sz="1338"/>
            </a:lvl5pPr>
            <a:lvl6pPr>
              <a:defRPr sz="1338"/>
            </a:lvl6pPr>
            <a:lvl7pPr>
              <a:defRPr sz="1338"/>
            </a:lvl7pPr>
            <a:lvl8pPr>
              <a:defRPr sz="1338"/>
            </a:lvl8pPr>
            <a:lvl9pPr>
              <a:defRPr sz="1338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318" y="1728312"/>
            <a:ext cx="1972775" cy="3201911"/>
          </a:xfrm>
        </p:spPr>
        <p:txBody>
          <a:bodyPr/>
          <a:lstStyle>
            <a:lvl1pPr marL="0" indent="0">
              <a:buNone/>
              <a:defRPr sz="1070"/>
            </a:lvl1pPr>
            <a:lvl2pPr marL="305821" indent="0">
              <a:buNone/>
              <a:defRPr sz="936"/>
            </a:lvl2pPr>
            <a:lvl3pPr marL="611642" indent="0">
              <a:buNone/>
              <a:defRPr sz="803"/>
            </a:lvl3pPr>
            <a:lvl4pPr marL="917463" indent="0">
              <a:buNone/>
              <a:defRPr sz="669"/>
            </a:lvl4pPr>
            <a:lvl5pPr marL="1223284" indent="0">
              <a:buNone/>
              <a:defRPr sz="669"/>
            </a:lvl5pPr>
            <a:lvl6pPr marL="1529105" indent="0">
              <a:buNone/>
              <a:defRPr sz="669"/>
            </a:lvl6pPr>
            <a:lvl7pPr marL="1834926" indent="0">
              <a:buNone/>
              <a:defRPr sz="669"/>
            </a:lvl7pPr>
            <a:lvl8pPr marL="2140748" indent="0">
              <a:buNone/>
              <a:defRPr sz="669"/>
            </a:lvl8pPr>
            <a:lvl9pPr marL="2446569" indent="0">
              <a:buNone/>
              <a:defRPr sz="669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3E62B-8402-4708-B816-52C74535AA18}" type="datetimeFigureOut">
              <a:rPr lang="en-US" smtClean="0"/>
              <a:t>1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20EA1-6DEE-4083-A547-33133D4F6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15024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318" y="384069"/>
            <a:ext cx="1972775" cy="1344242"/>
          </a:xfrm>
        </p:spPr>
        <p:txBody>
          <a:bodyPr anchor="b"/>
          <a:lstStyle>
            <a:lvl1pPr>
              <a:defRPr sz="21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0368" y="829484"/>
            <a:ext cx="3096548" cy="4094071"/>
          </a:xfrm>
        </p:spPr>
        <p:txBody>
          <a:bodyPr anchor="t"/>
          <a:lstStyle>
            <a:lvl1pPr marL="0" indent="0">
              <a:buNone/>
              <a:defRPr sz="2140"/>
            </a:lvl1pPr>
            <a:lvl2pPr marL="305821" indent="0">
              <a:buNone/>
              <a:defRPr sz="1873"/>
            </a:lvl2pPr>
            <a:lvl3pPr marL="611642" indent="0">
              <a:buNone/>
              <a:defRPr sz="1605"/>
            </a:lvl3pPr>
            <a:lvl4pPr marL="917463" indent="0">
              <a:buNone/>
              <a:defRPr sz="1338"/>
            </a:lvl4pPr>
            <a:lvl5pPr marL="1223284" indent="0">
              <a:buNone/>
              <a:defRPr sz="1338"/>
            </a:lvl5pPr>
            <a:lvl6pPr marL="1529105" indent="0">
              <a:buNone/>
              <a:defRPr sz="1338"/>
            </a:lvl6pPr>
            <a:lvl7pPr marL="1834926" indent="0">
              <a:buNone/>
              <a:defRPr sz="1338"/>
            </a:lvl7pPr>
            <a:lvl8pPr marL="2140748" indent="0">
              <a:buNone/>
              <a:defRPr sz="1338"/>
            </a:lvl8pPr>
            <a:lvl9pPr marL="2446569" indent="0">
              <a:buNone/>
              <a:defRPr sz="1338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318" y="1728312"/>
            <a:ext cx="1972775" cy="3201911"/>
          </a:xfrm>
        </p:spPr>
        <p:txBody>
          <a:bodyPr/>
          <a:lstStyle>
            <a:lvl1pPr marL="0" indent="0">
              <a:buNone/>
              <a:defRPr sz="1070"/>
            </a:lvl1pPr>
            <a:lvl2pPr marL="305821" indent="0">
              <a:buNone/>
              <a:defRPr sz="936"/>
            </a:lvl2pPr>
            <a:lvl3pPr marL="611642" indent="0">
              <a:buNone/>
              <a:defRPr sz="803"/>
            </a:lvl3pPr>
            <a:lvl4pPr marL="917463" indent="0">
              <a:buNone/>
              <a:defRPr sz="669"/>
            </a:lvl4pPr>
            <a:lvl5pPr marL="1223284" indent="0">
              <a:buNone/>
              <a:defRPr sz="669"/>
            </a:lvl5pPr>
            <a:lvl6pPr marL="1529105" indent="0">
              <a:buNone/>
              <a:defRPr sz="669"/>
            </a:lvl6pPr>
            <a:lvl7pPr marL="1834926" indent="0">
              <a:buNone/>
              <a:defRPr sz="669"/>
            </a:lvl7pPr>
            <a:lvl8pPr marL="2140748" indent="0">
              <a:buNone/>
              <a:defRPr sz="669"/>
            </a:lvl8pPr>
            <a:lvl9pPr marL="2446569" indent="0">
              <a:buNone/>
              <a:defRPr sz="669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3E62B-8402-4708-B816-52C74535AA18}" type="datetimeFigureOut">
              <a:rPr lang="en-US" smtClean="0"/>
              <a:t>1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20EA1-6DEE-4083-A547-33133D4F6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2337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519" y="306724"/>
            <a:ext cx="5275600" cy="1113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519" y="1533609"/>
            <a:ext cx="5275600" cy="365532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519" y="5339630"/>
            <a:ext cx="1376244" cy="30672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E3E62B-8402-4708-B816-52C74535AA18}" type="datetimeFigureOut">
              <a:rPr lang="en-US" smtClean="0"/>
              <a:t>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6139" y="5339630"/>
            <a:ext cx="2064365" cy="30672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19875" y="5339630"/>
            <a:ext cx="1376244" cy="30672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420EA1-6DEE-4083-A547-33133D4F6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35200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11642" rtl="0" eaLnBrk="1" latinLnBrk="0" hangingPunct="1">
        <a:lnSpc>
          <a:spcPct val="90000"/>
        </a:lnSpc>
        <a:spcBef>
          <a:spcPct val="0"/>
        </a:spcBef>
        <a:buNone/>
        <a:defRPr sz="294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2911" indent="-152911" algn="l" defTabSz="611642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3" kern="1200">
          <a:solidFill>
            <a:schemeClr val="tx1"/>
          </a:solidFill>
          <a:latin typeface="+mn-lt"/>
          <a:ea typeface="+mn-ea"/>
          <a:cs typeface="+mn-cs"/>
        </a:defRPr>
      </a:lvl1pPr>
      <a:lvl2pPr marL="458732" indent="-152911" algn="l" defTabSz="611642" rtl="0" eaLnBrk="1" latinLnBrk="0" hangingPunct="1">
        <a:lnSpc>
          <a:spcPct val="90000"/>
        </a:lnSpc>
        <a:spcBef>
          <a:spcPts val="334"/>
        </a:spcBef>
        <a:buFont typeface="Arial" panose="020B0604020202020204" pitchFamily="34" charset="0"/>
        <a:buChar char="•"/>
        <a:defRPr sz="1605" kern="1200">
          <a:solidFill>
            <a:schemeClr val="tx1"/>
          </a:solidFill>
          <a:latin typeface="+mn-lt"/>
          <a:ea typeface="+mn-ea"/>
          <a:cs typeface="+mn-cs"/>
        </a:defRPr>
      </a:lvl2pPr>
      <a:lvl3pPr marL="764553" indent="-152911" algn="l" defTabSz="611642" rtl="0" eaLnBrk="1" latinLnBrk="0" hangingPunct="1">
        <a:lnSpc>
          <a:spcPct val="90000"/>
        </a:lnSpc>
        <a:spcBef>
          <a:spcPts val="334"/>
        </a:spcBef>
        <a:buFont typeface="Arial" panose="020B0604020202020204" pitchFamily="34" charset="0"/>
        <a:buChar char="•"/>
        <a:defRPr sz="1338" kern="1200">
          <a:solidFill>
            <a:schemeClr val="tx1"/>
          </a:solidFill>
          <a:latin typeface="+mn-lt"/>
          <a:ea typeface="+mn-ea"/>
          <a:cs typeface="+mn-cs"/>
        </a:defRPr>
      </a:lvl3pPr>
      <a:lvl4pPr marL="1070374" indent="-152911" algn="l" defTabSz="611642" rtl="0" eaLnBrk="1" latinLnBrk="0" hangingPunct="1">
        <a:lnSpc>
          <a:spcPct val="90000"/>
        </a:lnSpc>
        <a:spcBef>
          <a:spcPts val="334"/>
        </a:spcBef>
        <a:buFont typeface="Arial" panose="020B0604020202020204" pitchFamily="34" charset="0"/>
        <a:buChar char="•"/>
        <a:defRPr sz="1204" kern="1200">
          <a:solidFill>
            <a:schemeClr val="tx1"/>
          </a:solidFill>
          <a:latin typeface="+mn-lt"/>
          <a:ea typeface="+mn-ea"/>
          <a:cs typeface="+mn-cs"/>
        </a:defRPr>
      </a:lvl4pPr>
      <a:lvl5pPr marL="1376195" indent="-152911" algn="l" defTabSz="611642" rtl="0" eaLnBrk="1" latinLnBrk="0" hangingPunct="1">
        <a:lnSpc>
          <a:spcPct val="90000"/>
        </a:lnSpc>
        <a:spcBef>
          <a:spcPts val="334"/>
        </a:spcBef>
        <a:buFont typeface="Arial" panose="020B0604020202020204" pitchFamily="34" charset="0"/>
        <a:buChar char="•"/>
        <a:defRPr sz="1204" kern="1200">
          <a:solidFill>
            <a:schemeClr val="tx1"/>
          </a:solidFill>
          <a:latin typeface="+mn-lt"/>
          <a:ea typeface="+mn-ea"/>
          <a:cs typeface="+mn-cs"/>
        </a:defRPr>
      </a:lvl5pPr>
      <a:lvl6pPr marL="1682016" indent="-152911" algn="l" defTabSz="611642" rtl="0" eaLnBrk="1" latinLnBrk="0" hangingPunct="1">
        <a:lnSpc>
          <a:spcPct val="90000"/>
        </a:lnSpc>
        <a:spcBef>
          <a:spcPts val="334"/>
        </a:spcBef>
        <a:buFont typeface="Arial" panose="020B0604020202020204" pitchFamily="34" charset="0"/>
        <a:buChar char="•"/>
        <a:defRPr sz="1204" kern="1200">
          <a:solidFill>
            <a:schemeClr val="tx1"/>
          </a:solidFill>
          <a:latin typeface="+mn-lt"/>
          <a:ea typeface="+mn-ea"/>
          <a:cs typeface="+mn-cs"/>
        </a:defRPr>
      </a:lvl6pPr>
      <a:lvl7pPr marL="1987837" indent="-152911" algn="l" defTabSz="611642" rtl="0" eaLnBrk="1" latinLnBrk="0" hangingPunct="1">
        <a:lnSpc>
          <a:spcPct val="90000"/>
        </a:lnSpc>
        <a:spcBef>
          <a:spcPts val="334"/>
        </a:spcBef>
        <a:buFont typeface="Arial" panose="020B0604020202020204" pitchFamily="34" charset="0"/>
        <a:buChar char="•"/>
        <a:defRPr sz="1204" kern="1200">
          <a:solidFill>
            <a:schemeClr val="tx1"/>
          </a:solidFill>
          <a:latin typeface="+mn-lt"/>
          <a:ea typeface="+mn-ea"/>
          <a:cs typeface="+mn-cs"/>
        </a:defRPr>
      </a:lvl7pPr>
      <a:lvl8pPr marL="2293658" indent="-152911" algn="l" defTabSz="611642" rtl="0" eaLnBrk="1" latinLnBrk="0" hangingPunct="1">
        <a:lnSpc>
          <a:spcPct val="90000"/>
        </a:lnSpc>
        <a:spcBef>
          <a:spcPts val="334"/>
        </a:spcBef>
        <a:buFont typeface="Arial" panose="020B0604020202020204" pitchFamily="34" charset="0"/>
        <a:buChar char="•"/>
        <a:defRPr sz="1204" kern="1200">
          <a:solidFill>
            <a:schemeClr val="tx1"/>
          </a:solidFill>
          <a:latin typeface="+mn-lt"/>
          <a:ea typeface="+mn-ea"/>
          <a:cs typeface="+mn-cs"/>
        </a:defRPr>
      </a:lvl8pPr>
      <a:lvl9pPr marL="2599479" indent="-152911" algn="l" defTabSz="611642" rtl="0" eaLnBrk="1" latinLnBrk="0" hangingPunct="1">
        <a:lnSpc>
          <a:spcPct val="90000"/>
        </a:lnSpc>
        <a:spcBef>
          <a:spcPts val="334"/>
        </a:spcBef>
        <a:buFont typeface="Arial" panose="020B0604020202020204" pitchFamily="34" charset="0"/>
        <a:buChar char="•"/>
        <a:defRPr sz="120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1642" rtl="0" eaLnBrk="1" latinLnBrk="0" hangingPunct="1">
        <a:defRPr sz="1204" kern="1200">
          <a:solidFill>
            <a:schemeClr val="tx1"/>
          </a:solidFill>
          <a:latin typeface="+mn-lt"/>
          <a:ea typeface="+mn-ea"/>
          <a:cs typeface="+mn-cs"/>
        </a:defRPr>
      </a:lvl1pPr>
      <a:lvl2pPr marL="305821" algn="l" defTabSz="611642" rtl="0" eaLnBrk="1" latinLnBrk="0" hangingPunct="1">
        <a:defRPr sz="1204" kern="1200">
          <a:solidFill>
            <a:schemeClr val="tx1"/>
          </a:solidFill>
          <a:latin typeface="+mn-lt"/>
          <a:ea typeface="+mn-ea"/>
          <a:cs typeface="+mn-cs"/>
        </a:defRPr>
      </a:lvl2pPr>
      <a:lvl3pPr marL="611642" algn="l" defTabSz="611642" rtl="0" eaLnBrk="1" latinLnBrk="0" hangingPunct="1">
        <a:defRPr sz="1204" kern="1200">
          <a:solidFill>
            <a:schemeClr val="tx1"/>
          </a:solidFill>
          <a:latin typeface="+mn-lt"/>
          <a:ea typeface="+mn-ea"/>
          <a:cs typeface="+mn-cs"/>
        </a:defRPr>
      </a:lvl3pPr>
      <a:lvl4pPr marL="917463" algn="l" defTabSz="611642" rtl="0" eaLnBrk="1" latinLnBrk="0" hangingPunct="1">
        <a:defRPr sz="1204" kern="1200">
          <a:solidFill>
            <a:schemeClr val="tx1"/>
          </a:solidFill>
          <a:latin typeface="+mn-lt"/>
          <a:ea typeface="+mn-ea"/>
          <a:cs typeface="+mn-cs"/>
        </a:defRPr>
      </a:lvl4pPr>
      <a:lvl5pPr marL="1223284" algn="l" defTabSz="611642" rtl="0" eaLnBrk="1" latinLnBrk="0" hangingPunct="1">
        <a:defRPr sz="1204" kern="1200">
          <a:solidFill>
            <a:schemeClr val="tx1"/>
          </a:solidFill>
          <a:latin typeface="+mn-lt"/>
          <a:ea typeface="+mn-ea"/>
          <a:cs typeface="+mn-cs"/>
        </a:defRPr>
      </a:lvl5pPr>
      <a:lvl6pPr marL="1529105" algn="l" defTabSz="611642" rtl="0" eaLnBrk="1" latinLnBrk="0" hangingPunct="1">
        <a:defRPr sz="1204" kern="1200">
          <a:solidFill>
            <a:schemeClr val="tx1"/>
          </a:solidFill>
          <a:latin typeface="+mn-lt"/>
          <a:ea typeface="+mn-ea"/>
          <a:cs typeface="+mn-cs"/>
        </a:defRPr>
      </a:lvl6pPr>
      <a:lvl7pPr marL="1834926" algn="l" defTabSz="611642" rtl="0" eaLnBrk="1" latinLnBrk="0" hangingPunct="1">
        <a:defRPr sz="1204" kern="1200">
          <a:solidFill>
            <a:schemeClr val="tx1"/>
          </a:solidFill>
          <a:latin typeface="+mn-lt"/>
          <a:ea typeface="+mn-ea"/>
          <a:cs typeface="+mn-cs"/>
        </a:defRPr>
      </a:lvl7pPr>
      <a:lvl8pPr marL="2140748" algn="l" defTabSz="611642" rtl="0" eaLnBrk="1" latinLnBrk="0" hangingPunct="1">
        <a:defRPr sz="1204" kern="1200">
          <a:solidFill>
            <a:schemeClr val="tx1"/>
          </a:solidFill>
          <a:latin typeface="+mn-lt"/>
          <a:ea typeface="+mn-ea"/>
          <a:cs typeface="+mn-cs"/>
        </a:defRPr>
      </a:lvl8pPr>
      <a:lvl9pPr marL="2446569" algn="l" defTabSz="611642" rtl="0" eaLnBrk="1" latinLnBrk="0" hangingPunct="1">
        <a:defRPr sz="120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Google Shape;146;p21">
            <a:extLst>
              <a:ext uri="{FF2B5EF4-FFF2-40B4-BE49-F238E27FC236}">
                <a16:creationId xmlns:a16="http://schemas.microsoft.com/office/drawing/2014/main" id="{D81FEA01-3FC7-4BEF-A740-E814217C3239}"/>
              </a:ext>
            </a:extLst>
          </p:cNvPr>
          <p:cNvPicPr preferRelativeResize="0"/>
          <p:nvPr/>
        </p:nvPicPr>
        <p:blipFill rotWithShape="1">
          <a:blip r:embed="rId3">
            <a:alphaModFix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-20000"/>
                    </a14:imgEffect>
                  </a14:imgLayer>
                </a14:imgProps>
              </a:ext>
            </a:extLst>
          </a:blip>
          <a:srcRect l="4405" t="7510" r="12943" b="27113"/>
          <a:stretch/>
        </p:blipFill>
        <p:spPr>
          <a:xfrm>
            <a:off x="733661" y="3820337"/>
            <a:ext cx="4330025" cy="1917290"/>
          </a:xfrm>
          <a:prstGeom prst="rect">
            <a:avLst/>
          </a:prstGeom>
          <a:noFill/>
          <a:ln>
            <a:noFill/>
          </a:ln>
        </p:spPr>
      </p:pic>
      <p:sp>
        <p:nvSpPr>
          <p:cNvPr id="64" name="Google Shape;167;p21">
            <a:extLst>
              <a:ext uri="{FF2B5EF4-FFF2-40B4-BE49-F238E27FC236}">
                <a16:creationId xmlns:a16="http://schemas.microsoft.com/office/drawing/2014/main" id="{5DB3E9FC-1951-47D0-9EC4-6E1923983C6B}"/>
              </a:ext>
            </a:extLst>
          </p:cNvPr>
          <p:cNvSpPr txBox="1"/>
          <p:nvPr/>
        </p:nvSpPr>
        <p:spPr>
          <a:xfrm rot="18361349">
            <a:off x="913827" y="3361237"/>
            <a:ext cx="756846" cy="257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RzI_</a:t>
            </a:r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RJ1</a:t>
            </a:r>
            <a:endParaRPr sz="900" b="1" dirty="0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sp>
        <p:nvSpPr>
          <p:cNvPr id="65" name="Google Shape;168;p21">
            <a:extLst>
              <a:ext uri="{FF2B5EF4-FFF2-40B4-BE49-F238E27FC236}">
                <a16:creationId xmlns:a16="http://schemas.microsoft.com/office/drawing/2014/main" id="{793781C9-0C2C-4BD1-BC2A-AB50FDBFFE8E}"/>
              </a:ext>
            </a:extLst>
          </p:cNvPr>
          <p:cNvSpPr txBox="1"/>
          <p:nvPr/>
        </p:nvSpPr>
        <p:spPr>
          <a:xfrm rot="18361816">
            <a:off x="1204064" y="3406756"/>
            <a:ext cx="670724" cy="2438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RzI_</a:t>
            </a:r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33</a:t>
            </a:r>
            <a:endParaRPr sz="900" b="1" dirty="0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sp>
        <p:nvSpPr>
          <p:cNvPr id="66" name="Google Shape;169;p21">
            <a:extLst>
              <a:ext uri="{FF2B5EF4-FFF2-40B4-BE49-F238E27FC236}">
                <a16:creationId xmlns:a16="http://schemas.microsoft.com/office/drawing/2014/main" id="{04705F6F-A423-45BF-9932-736C250F99DD}"/>
              </a:ext>
            </a:extLst>
          </p:cNvPr>
          <p:cNvSpPr txBox="1"/>
          <p:nvPr/>
        </p:nvSpPr>
        <p:spPr>
          <a:xfrm rot="18361232">
            <a:off x="1460243" y="3348364"/>
            <a:ext cx="788667" cy="257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Rzll_</a:t>
            </a:r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RJ1</a:t>
            </a:r>
            <a:endParaRPr sz="900" b="1" dirty="0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sp>
        <p:nvSpPr>
          <p:cNvPr id="67" name="Google Shape;170;p21">
            <a:extLst>
              <a:ext uri="{FF2B5EF4-FFF2-40B4-BE49-F238E27FC236}">
                <a16:creationId xmlns:a16="http://schemas.microsoft.com/office/drawing/2014/main" id="{6E4E7EE8-DCB0-44C4-ABC0-AAC1332CD34A}"/>
              </a:ext>
            </a:extLst>
          </p:cNvPr>
          <p:cNvSpPr txBox="1"/>
          <p:nvPr/>
        </p:nvSpPr>
        <p:spPr>
          <a:xfrm rot="18361816">
            <a:off x="1740587" y="3378050"/>
            <a:ext cx="741715" cy="2438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Rzll</a:t>
            </a:r>
            <a:r>
              <a:rPr lang="en-US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_</a:t>
            </a:r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33</a:t>
            </a:r>
            <a:endParaRPr sz="900" b="1" dirty="0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sp>
        <p:nvSpPr>
          <p:cNvPr id="68" name="Google Shape;171;p21">
            <a:extLst>
              <a:ext uri="{FF2B5EF4-FFF2-40B4-BE49-F238E27FC236}">
                <a16:creationId xmlns:a16="http://schemas.microsoft.com/office/drawing/2014/main" id="{FB9085A0-34BC-48A5-9BBF-39C51E549EA5}"/>
              </a:ext>
            </a:extLst>
          </p:cNvPr>
          <p:cNvSpPr txBox="1"/>
          <p:nvPr/>
        </p:nvSpPr>
        <p:spPr>
          <a:xfrm rot="18360902">
            <a:off x="1904526" y="3121811"/>
            <a:ext cx="1348813" cy="257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EGFP</a:t>
            </a:r>
            <a:r>
              <a:rPr lang="en-US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-hDHFR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_</a:t>
            </a:r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RJ1</a:t>
            </a:r>
            <a:endParaRPr sz="900" b="1" dirty="0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sp>
        <p:nvSpPr>
          <p:cNvPr id="69" name="Google Shape;172;p21">
            <a:extLst>
              <a:ext uri="{FF2B5EF4-FFF2-40B4-BE49-F238E27FC236}">
                <a16:creationId xmlns:a16="http://schemas.microsoft.com/office/drawing/2014/main" id="{174ECE43-B092-47F1-8DBC-4BEC73D1C6C1}"/>
              </a:ext>
            </a:extLst>
          </p:cNvPr>
          <p:cNvSpPr txBox="1"/>
          <p:nvPr/>
        </p:nvSpPr>
        <p:spPr>
          <a:xfrm rot="18361816">
            <a:off x="2202440" y="3159904"/>
            <a:ext cx="1281208" cy="2438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EGFP</a:t>
            </a:r>
            <a:r>
              <a:rPr lang="en-US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-hDHFR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_i33</a:t>
            </a:r>
            <a:endParaRPr sz="900" b="1" dirty="0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sp>
        <p:nvSpPr>
          <p:cNvPr id="70" name="Google Shape;173;p21">
            <a:extLst>
              <a:ext uri="{FF2B5EF4-FFF2-40B4-BE49-F238E27FC236}">
                <a16:creationId xmlns:a16="http://schemas.microsoft.com/office/drawing/2014/main" id="{731DF475-B499-4BFA-9EED-A3C77F9A15C8}"/>
              </a:ext>
            </a:extLst>
          </p:cNvPr>
          <p:cNvSpPr txBox="1"/>
          <p:nvPr/>
        </p:nvSpPr>
        <p:spPr>
          <a:xfrm rot="18361349">
            <a:off x="2546053" y="3275859"/>
            <a:ext cx="967972" cy="257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R</a:t>
            </a:r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SETC_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RJ1</a:t>
            </a:r>
            <a:endParaRPr sz="900" b="1" dirty="0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sp>
        <p:nvSpPr>
          <p:cNvPr id="71" name="Google Shape;174;p21">
            <a:extLst>
              <a:ext uri="{FF2B5EF4-FFF2-40B4-BE49-F238E27FC236}">
                <a16:creationId xmlns:a16="http://schemas.microsoft.com/office/drawing/2014/main" id="{CFB211B3-CA50-4765-AB98-E723376BA7D0}"/>
              </a:ext>
            </a:extLst>
          </p:cNvPr>
          <p:cNvSpPr txBox="1"/>
          <p:nvPr/>
        </p:nvSpPr>
        <p:spPr>
          <a:xfrm rot="18361349">
            <a:off x="2869636" y="3315050"/>
            <a:ext cx="871058" cy="257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R</a:t>
            </a:r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SETC_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33</a:t>
            </a:r>
            <a:endParaRPr sz="900" b="1" dirty="0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sp>
        <p:nvSpPr>
          <p:cNvPr id="72" name="Google Shape;175;p21">
            <a:extLst>
              <a:ext uri="{FF2B5EF4-FFF2-40B4-BE49-F238E27FC236}">
                <a16:creationId xmlns:a16="http://schemas.microsoft.com/office/drawing/2014/main" id="{CC6D8B8E-644D-4C6E-B65A-0567B1844F55}"/>
              </a:ext>
            </a:extLst>
          </p:cNvPr>
          <p:cNvSpPr txBox="1"/>
          <p:nvPr/>
        </p:nvSpPr>
        <p:spPr>
          <a:xfrm rot="18360642">
            <a:off x="3119384" y="3313047"/>
            <a:ext cx="875931" cy="257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i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glmS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_</a:t>
            </a:r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RJ1</a:t>
            </a:r>
            <a:endParaRPr sz="900" b="1" dirty="0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sp>
        <p:nvSpPr>
          <p:cNvPr id="73" name="Google Shape;176;p21">
            <a:extLst>
              <a:ext uri="{FF2B5EF4-FFF2-40B4-BE49-F238E27FC236}">
                <a16:creationId xmlns:a16="http://schemas.microsoft.com/office/drawing/2014/main" id="{917B7DAC-7190-42D5-8CF3-817F9B22A6E3}"/>
              </a:ext>
            </a:extLst>
          </p:cNvPr>
          <p:cNvSpPr txBox="1"/>
          <p:nvPr/>
        </p:nvSpPr>
        <p:spPr>
          <a:xfrm rot="18361322">
            <a:off x="3431510" y="3376457"/>
            <a:ext cx="719207" cy="257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i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glmS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_</a:t>
            </a:r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33</a:t>
            </a:r>
            <a:endParaRPr sz="900" b="1" dirty="0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sp>
        <p:nvSpPr>
          <p:cNvPr id="74" name="Google Shape;177;p21">
            <a:extLst>
              <a:ext uri="{FF2B5EF4-FFF2-40B4-BE49-F238E27FC236}">
                <a16:creationId xmlns:a16="http://schemas.microsoft.com/office/drawing/2014/main" id="{590B23DE-32CB-4D9F-A71F-6ED68B5FC878}"/>
              </a:ext>
            </a:extLst>
          </p:cNvPr>
          <p:cNvSpPr txBox="1"/>
          <p:nvPr/>
        </p:nvSpPr>
        <p:spPr>
          <a:xfrm rot="18360642">
            <a:off x="3712712" y="3346115"/>
            <a:ext cx="794172" cy="257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M9_</a:t>
            </a:r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RJ1</a:t>
            </a:r>
            <a:endParaRPr sz="900" b="1" dirty="0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sp>
        <p:nvSpPr>
          <p:cNvPr id="75" name="Google Shape;178;p21">
            <a:extLst>
              <a:ext uri="{FF2B5EF4-FFF2-40B4-BE49-F238E27FC236}">
                <a16:creationId xmlns:a16="http://schemas.microsoft.com/office/drawing/2014/main" id="{0A6D2A6B-9166-42F4-9964-F16B464FE852}"/>
              </a:ext>
            </a:extLst>
          </p:cNvPr>
          <p:cNvSpPr txBox="1"/>
          <p:nvPr/>
        </p:nvSpPr>
        <p:spPr>
          <a:xfrm rot="18361322">
            <a:off x="4013861" y="3376457"/>
            <a:ext cx="719207" cy="257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M9_</a:t>
            </a:r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33</a:t>
            </a:r>
            <a:endParaRPr sz="900" b="1" dirty="0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sp>
        <p:nvSpPr>
          <p:cNvPr id="76" name="Google Shape;179;p21">
            <a:extLst>
              <a:ext uri="{FF2B5EF4-FFF2-40B4-BE49-F238E27FC236}">
                <a16:creationId xmlns:a16="http://schemas.microsoft.com/office/drawing/2014/main" id="{1D39157A-F59F-4F2C-9CBA-A05F661C7202}"/>
              </a:ext>
            </a:extLst>
          </p:cNvPr>
          <p:cNvSpPr txBox="1"/>
          <p:nvPr/>
        </p:nvSpPr>
        <p:spPr>
          <a:xfrm rot="18362635">
            <a:off x="4246229" y="3118471"/>
            <a:ext cx="1321576" cy="3580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RzI</a:t>
            </a:r>
            <a:endParaRPr sz="900" b="1" dirty="0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cxnSp>
        <p:nvCxnSpPr>
          <p:cNvPr id="77" name="Straight Arrow Connector 76">
            <a:extLst>
              <a:ext uri="{FF2B5EF4-FFF2-40B4-BE49-F238E27FC236}">
                <a16:creationId xmlns:a16="http://schemas.microsoft.com/office/drawing/2014/main" id="{9E08FA00-2A7F-4F80-8A4B-62AB640D8DF5}"/>
              </a:ext>
            </a:extLst>
          </p:cNvPr>
          <p:cNvCxnSpPr>
            <a:cxnSpLocks/>
          </p:cNvCxnSpPr>
          <p:nvPr/>
        </p:nvCxnSpPr>
        <p:spPr>
          <a:xfrm flipH="1">
            <a:off x="648803" y="5237430"/>
            <a:ext cx="145930" cy="0"/>
          </a:xfrm>
          <a:prstGeom prst="straightConnector1">
            <a:avLst/>
          </a:prstGeom>
          <a:ln w="28575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Arrow Connector 77">
            <a:extLst>
              <a:ext uri="{FF2B5EF4-FFF2-40B4-BE49-F238E27FC236}">
                <a16:creationId xmlns:a16="http://schemas.microsoft.com/office/drawing/2014/main" id="{72CBB746-1308-43FF-B972-C2BFC93741C5}"/>
              </a:ext>
            </a:extLst>
          </p:cNvPr>
          <p:cNvCxnSpPr>
            <a:cxnSpLocks/>
          </p:cNvCxnSpPr>
          <p:nvPr/>
        </p:nvCxnSpPr>
        <p:spPr>
          <a:xfrm flipH="1">
            <a:off x="648814" y="5351104"/>
            <a:ext cx="141079" cy="0"/>
          </a:xfrm>
          <a:prstGeom prst="straightConnector1">
            <a:avLst/>
          </a:prstGeom>
          <a:ln w="28575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F9AD8ED8-11A8-4A5E-BB0D-5696B8EAEDF2}"/>
              </a:ext>
            </a:extLst>
          </p:cNvPr>
          <p:cNvSpPr txBox="1"/>
          <p:nvPr/>
        </p:nvSpPr>
        <p:spPr>
          <a:xfrm>
            <a:off x="95897" y="5071787"/>
            <a:ext cx="59533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.0 kb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26D3E48F-E118-468E-8FE3-C7664C101F52}"/>
              </a:ext>
            </a:extLst>
          </p:cNvPr>
          <p:cNvSpPr txBox="1"/>
          <p:nvPr/>
        </p:nvSpPr>
        <p:spPr>
          <a:xfrm>
            <a:off x="95907" y="5225703"/>
            <a:ext cx="59533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0.7 kb</a:t>
            </a:r>
          </a:p>
        </p:txBody>
      </p:sp>
      <p:cxnSp>
        <p:nvCxnSpPr>
          <p:cNvPr id="81" name="Straight Arrow Connector 80">
            <a:extLst>
              <a:ext uri="{FF2B5EF4-FFF2-40B4-BE49-F238E27FC236}">
                <a16:creationId xmlns:a16="http://schemas.microsoft.com/office/drawing/2014/main" id="{9AC28E0D-F205-4E05-8554-D15A1D33DD21}"/>
              </a:ext>
            </a:extLst>
          </p:cNvPr>
          <p:cNvCxnSpPr>
            <a:cxnSpLocks/>
          </p:cNvCxnSpPr>
          <p:nvPr/>
        </p:nvCxnSpPr>
        <p:spPr>
          <a:xfrm flipH="1">
            <a:off x="5022969" y="5173930"/>
            <a:ext cx="145930" cy="0"/>
          </a:xfrm>
          <a:prstGeom prst="straightConnector1">
            <a:avLst/>
          </a:prstGeom>
          <a:ln w="28575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Arrow Connector 81">
            <a:extLst>
              <a:ext uri="{FF2B5EF4-FFF2-40B4-BE49-F238E27FC236}">
                <a16:creationId xmlns:a16="http://schemas.microsoft.com/office/drawing/2014/main" id="{03FADF6A-B432-44A1-92E9-EB6DB13C4303}"/>
              </a:ext>
            </a:extLst>
          </p:cNvPr>
          <p:cNvCxnSpPr>
            <a:cxnSpLocks/>
          </p:cNvCxnSpPr>
          <p:nvPr/>
        </p:nvCxnSpPr>
        <p:spPr>
          <a:xfrm flipH="1">
            <a:off x="5022981" y="5283371"/>
            <a:ext cx="141079" cy="0"/>
          </a:xfrm>
          <a:prstGeom prst="straightConnector1">
            <a:avLst/>
          </a:prstGeom>
          <a:ln w="28575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id="{B0B5E061-6C4B-4600-9338-BE468DBD4DBA}"/>
              </a:ext>
            </a:extLst>
          </p:cNvPr>
          <p:cNvSpPr txBox="1"/>
          <p:nvPr/>
        </p:nvSpPr>
        <p:spPr>
          <a:xfrm>
            <a:off x="5097631" y="5017379"/>
            <a:ext cx="59533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.0 kb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A5E461D2-682E-4F43-9753-B28621228FCC}"/>
              </a:ext>
            </a:extLst>
          </p:cNvPr>
          <p:cNvSpPr txBox="1"/>
          <p:nvPr/>
        </p:nvSpPr>
        <p:spPr>
          <a:xfrm>
            <a:off x="5097642" y="5171295"/>
            <a:ext cx="59533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0.7 kb</a:t>
            </a:r>
          </a:p>
        </p:txBody>
      </p:sp>
      <p:sp>
        <p:nvSpPr>
          <p:cNvPr id="85" name="Google Shape;167;p21">
            <a:extLst>
              <a:ext uri="{FF2B5EF4-FFF2-40B4-BE49-F238E27FC236}">
                <a16:creationId xmlns:a16="http://schemas.microsoft.com/office/drawing/2014/main" id="{295F8864-5876-450E-9E77-D7AEA5708257}"/>
              </a:ext>
            </a:extLst>
          </p:cNvPr>
          <p:cNvSpPr txBox="1"/>
          <p:nvPr/>
        </p:nvSpPr>
        <p:spPr>
          <a:xfrm>
            <a:off x="732663" y="3539174"/>
            <a:ext cx="286485" cy="2510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M</a:t>
            </a:r>
            <a:endParaRPr sz="900" b="1" dirty="0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sp>
        <p:nvSpPr>
          <p:cNvPr id="86" name="Google Shape;167;p21">
            <a:extLst>
              <a:ext uri="{FF2B5EF4-FFF2-40B4-BE49-F238E27FC236}">
                <a16:creationId xmlns:a16="http://schemas.microsoft.com/office/drawing/2014/main" id="{82D814E2-2E7E-4D1E-89D2-1F40EE6ACC9B}"/>
              </a:ext>
            </a:extLst>
          </p:cNvPr>
          <p:cNvSpPr txBox="1"/>
          <p:nvPr/>
        </p:nvSpPr>
        <p:spPr>
          <a:xfrm>
            <a:off x="4722553" y="3539174"/>
            <a:ext cx="286485" cy="2510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M</a:t>
            </a:r>
            <a:endParaRPr sz="900" b="1" dirty="0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F471549C-E7E5-47B2-9909-3868AA094FA3}"/>
              </a:ext>
            </a:extLst>
          </p:cNvPr>
          <p:cNvSpPr txBox="1"/>
          <p:nvPr/>
        </p:nvSpPr>
        <p:spPr>
          <a:xfrm>
            <a:off x="-58311" y="232791"/>
            <a:ext cx="4644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F7F8CC33-A9A7-4792-B0C6-57D33CA646EB}"/>
              </a:ext>
            </a:extLst>
          </p:cNvPr>
          <p:cNvSpPr txBox="1"/>
          <p:nvPr/>
        </p:nvSpPr>
        <p:spPr>
          <a:xfrm>
            <a:off x="-58311" y="3182489"/>
            <a:ext cx="4644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89" name="Google Shape;147;p21">
            <a:extLst>
              <a:ext uri="{FF2B5EF4-FFF2-40B4-BE49-F238E27FC236}">
                <a16:creationId xmlns:a16="http://schemas.microsoft.com/office/drawing/2014/main" id="{72C63EFF-C8FC-4B1C-B51B-938F389BE1D3}"/>
              </a:ext>
            </a:extLst>
          </p:cNvPr>
          <p:cNvPicPr preferRelativeResize="0"/>
          <p:nvPr/>
        </p:nvPicPr>
        <p:blipFill rotWithShape="1">
          <a:blip r:embed="rId5">
            <a:alphaModFix/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-20000"/>
                    </a14:imgEffect>
                  </a14:imgLayer>
                </a14:imgProps>
              </a:ext>
            </a:extLst>
          </a:blip>
          <a:srcRect l="8162" t="9346" r="9301" b="32276"/>
          <a:stretch/>
        </p:blipFill>
        <p:spPr>
          <a:xfrm>
            <a:off x="3845158" y="890172"/>
            <a:ext cx="2058166" cy="1724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90" name="Google Shape;148;p21">
            <a:extLst>
              <a:ext uri="{FF2B5EF4-FFF2-40B4-BE49-F238E27FC236}">
                <a16:creationId xmlns:a16="http://schemas.microsoft.com/office/drawing/2014/main" id="{1D13771B-C53D-40F4-A912-2F51BF871A08}"/>
              </a:ext>
            </a:extLst>
          </p:cNvPr>
          <p:cNvPicPr preferRelativeResize="0"/>
          <p:nvPr/>
        </p:nvPicPr>
        <p:blipFill rotWithShape="1">
          <a:blip r:embed="rId7">
            <a:alphaModFix/>
          </a:blip>
          <a:srcRect l="3923" t="6208" r="19288" b="24958"/>
          <a:stretch/>
        </p:blipFill>
        <p:spPr>
          <a:xfrm>
            <a:off x="667745" y="900563"/>
            <a:ext cx="2320575" cy="1724800"/>
          </a:xfrm>
          <a:prstGeom prst="rect">
            <a:avLst/>
          </a:prstGeom>
          <a:noFill/>
          <a:ln>
            <a:noFill/>
          </a:ln>
        </p:spPr>
      </p:pic>
      <p:sp>
        <p:nvSpPr>
          <p:cNvPr id="91" name="Google Shape;151;p21">
            <a:extLst>
              <a:ext uri="{FF2B5EF4-FFF2-40B4-BE49-F238E27FC236}">
                <a16:creationId xmlns:a16="http://schemas.microsoft.com/office/drawing/2014/main" id="{D3237B76-EED7-4C8B-91BB-A84F9CF8E9AF}"/>
              </a:ext>
            </a:extLst>
          </p:cNvPr>
          <p:cNvSpPr txBox="1"/>
          <p:nvPr/>
        </p:nvSpPr>
        <p:spPr>
          <a:xfrm rot="19084867">
            <a:off x="776633" y="425593"/>
            <a:ext cx="933459" cy="257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RzI_</a:t>
            </a:r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RJ1</a:t>
            </a:r>
            <a:endParaRPr sz="900" b="1" dirty="0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sp>
        <p:nvSpPr>
          <p:cNvPr id="92" name="Google Shape;152;p21">
            <a:extLst>
              <a:ext uri="{FF2B5EF4-FFF2-40B4-BE49-F238E27FC236}">
                <a16:creationId xmlns:a16="http://schemas.microsoft.com/office/drawing/2014/main" id="{D733FF40-1084-4E18-97F3-7416DAE1AF2B}"/>
              </a:ext>
            </a:extLst>
          </p:cNvPr>
          <p:cNvSpPr txBox="1"/>
          <p:nvPr/>
        </p:nvSpPr>
        <p:spPr>
          <a:xfrm rot="19085334">
            <a:off x="983192" y="432124"/>
            <a:ext cx="949114" cy="2438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RzI_</a:t>
            </a:r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33</a:t>
            </a:r>
            <a:endParaRPr sz="900" b="1" dirty="0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sp>
        <p:nvSpPr>
          <p:cNvPr id="93" name="Google Shape;153;p21">
            <a:extLst>
              <a:ext uri="{FF2B5EF4-FFF2-40B4-BE49-F238E27FC236}">
                <a16:creationId xmlns:a16="http://schemas.microsoft.com/office/drawing/2014/main" id="{0F0AA31E-C27F-4AA9-8AFA-15EF88B6A435}"/>
              </a:ext>
            </a:extLst>
          </p:cNvPr>
          <p:cNvSpPr txBox="1"/>
          <p:nvPr/>
        </p:nvSpPr>
        <p:spPr>
          <a:xfrm rot="19086153">
            <a:off x="1159921" y="337693"/>
            <a:ext cx="1279142" cy="22580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RzI</a:t>
            </a:r>
            <a:endParaRPr sz="900" b="1" dirty="0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sp>
        <p:nvSpPr>
          <p:cNvPr id="94" name="Google Shape;154;p21">
            <a:extLst>
              <a:ext uri="{FF2B5EF4-FFF2-40B4-BE49-F238E27FC236}">
                <a16:creationId xmlns:a16="http://schemas.microsoft.com/office/drawing/2014/main" id="{7B4EB8A6-B46D-4478-BFDB-BE9B50E90DFD}"/>
              </a:ext>
            </a:extLst>
          </p:cNvPr>
          <p:cNvSpPr txBox="1"/>
          <p:nvPr/>
        </p:nvSpPr>
        <p:spPr>
          <a:xfrm rot="19084750">
            <a:off x="1415173" y="387178"/>
            <a:ext cx="1048429" cy="257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Rzll_</a:t>
            </a:r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RJ1</a:t>
            </a:r>
            <a:endParaRPr sz="900" b="1" dirty="0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sp>
        <p:nvSpPr>
          <p:cNvPr id="95" name="Google Shape;155;p21">
            <a:extLst>
              <a:ext uri="{FF2B5EF4-FFF2-40B4-BE49-F238E27FC236}">
                <a16:creationId xmlns:a16="http://schemas.microsoft.com/office/drawing/2014/main" id="{150BA9A3-18ED-45EE-BC86-BE1B07D299E4}"/>
              </a:ext>
            </a:extLst>
          </p:cNvPr>
          <p:cNvSpPr txBox="1"/>
          <p:nvPr/>
        </p:nvSpPr>
        <p:spPr>
          <a:xfrm rot="19085334">
            <a:off x="1622379" y="351684"/>
            <a:ext cx="1189960" cy="2438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Rzll_</a:t>
            </a:r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33</a:t>
            </a:r>
            <a:endParaRPr sz="900" b="1" dirty="0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sp>
        <p:nvSpPr>
          <p:cNvPr id="96" name="Google Shape;156;p21">
            <a:extLst>
              <a:ext uri="{FF2B5EF4-FFF2-40B4-BE49-F238E27FC236}">
                <a16:creationId xmlns:a16="http://schemas.microsoft.com/office/drawing/2014/main" id="{5C656A58-DE25-4FFB-ACA5-110F715C544E}"/>
              </a:ext>
            </a:extLst>
          </p:cNvPr>
          <p:cNvSpPr txBox="1"/>
          <p:nvPr/>
        </p:nvSpPr>
        <p:spPr>
          <a:xfrm rot="19086153">
            <a:off x="1794650" y="297099"/>
            <a:ext cx="1448343" cy="22580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RzIl</a:t>
            </a:r>
            <a:endParaRPr sz="900" b="1" dirty="0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sp>
        <p:nvSpPr>
          <p:cNvPr id="97" name="Google Shape;157;p21">
            <a:extLst>
              <a:ext uri="{FF2B5EF4-FFF2-40B4-BE49-F238E27FC236}">
                <a16:creationId xmlns:a16="http://schemas.microsoft.com/office/drawing/2014/main" id="{0504C683-1AFC-409F-85A2-16E36B9DE319}"/>
              </a:ext>
            </a:extLst>
          </p:cNvPr>
          <p:cNvSpPr txBox="1"/>
          <p:nvPr/>
        </p:nvSpPr>
        <p:spPr>
          <a:xfrm rot="19084420">
            <a:off x="2078235" y="329612"/>
            <a:ext cx="1268246" cy="257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EGFP-hDHFR_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RJ1</a:t>
            </a:r>
            <a:endParaRPr sz="900" b="1" dirty="0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sp>
        <p:nvSpPr>
          <p:cNvPr id="98" name="Google Shape;158;p21">
            <a:extLst>
              <a:ext uri="{FF2B5EF4-FFF2-40B4-BE49-F238E27FC236}">
                <a16:creationId xmlns:a16="http://schemas.microsoft.com/office/drawing/2014/main" id="{9CF809B8-0238-47D4-BF35-814323FB5A95}"/>
              </a:ext>
            </a:extLst>
          </p:cNvPr>
          <p:cNvSpPr txBox="1"/>
          <p:nvPr/>
        </p:nvSpPr>
        <p:spPr>
          <a:xfrm rot="19085334">
            <a:off x="2265705" y="286938"/>
            <a:ext cx="1392505" cy="2579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EGFP-hDHFR_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33</a:t>
            </a:r>
            <a:endParaRPr sz="900" b="1" dirty="0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sp>
        <p:nvSpPr>
          <p:cNvPr id="99" name="Google Shape;159;p21">
            <a:extLst>
              <a:ext uri="{FF2B5EF4-FFF2-40B4-BE49-F238E27FC236}">
                <a16:creationId xmlns:a16="http://schemas.microsoft.com/office/drawing/2014/main" id="{25DED97B-E591-4D01-B3D5-2A97230544D3}"/>
              </a:ext>
            </a:extLst>
          </p:cNvPr>
          <p:cNvSpPr txBox="1"/>
          <p:nvPr/>
        </p:nvSpPr>
        <p:spPr>
          <a:xfrm rot="19086458">
            <a:off x="2520996" y="401612"/>
            <a:ext cx="1087796" cy="22580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EGFP</a:t>
            </a:r>
            <a:r>
              <a:rPr lang="en-US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-hDHFR</a:t>
            </a:r>
            <a:endParaRPr sz="900" b="1" dirty="0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sp>
        <p:nvSpPr>
          <p:cNvPr id="100" name="Google Shape;160;p21">
            <a:extLst>
              <a:ext uri="{FF2B5EF4-FFF2-40B4-BE49-F238E27FC236}">
                <a16:creationId xmlns:a16="http://schemas.microsoft.com/office/drawing/2014/main" id="{211A2A1E-A3D4-4110-A59A-8C4841A6C716}"/>
              </a:ext>
            </a:extLst>
          </p:cNvPr>
          <p:cNvSpPr txBox="1"/>
          <p:nvPr/>
        </p:nvSpPr>
        <p:spPr>
          <a:xfrm rot="19360532">
            <a:off x="3980035" y="402507"/>
            <a:ext cx="1011557" cy="257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R</a:t>
            </a:r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SETC_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RJ1</a:t>
            </a:r>
            <a:endParaRPr sz="900" b="1" dirty="0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sp>
        <p:nvSpPr>
          <p:cNvPr id="101" name="Google Shape;161;p21">
            <a:extLst>
              <a:ext uri="{FF2B5EF4-FFF2-40B4-BE49-F238E27FC236}">
                <a16:creationId xmlns:a16="http://schemas.microsoft.com/office/drawing/2014/main" id="{DD11335D-CCDA-43F3-8740-E2F844A0F6E5}"/>
              </a:ext>
            </a:extLst>
          </p:cNvPr>
          <p:cNvSpPr txBox="1"/>
          <p:nvPr/>
        </p:nvSpPr>
        <p:spPr>
          <a:xfrm rot="19360532">
            <a:off x="4213274" y="388065"/>
            <a:ext cx="1059196" cy="257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R</a:t>
            </a:r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SETC_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33</a:t>
            </a:r>
            <a:endParaRPr sz="900" b="1" dirty="0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sp>
        <p:nvSpPr>
          <p:cNvPr id="102" name="Google Shape;162;p21">
            <a:extLst>
              <a:ext uri="{FF2B5EF4-FFF2-40B4-BE49-F238E27FC236}">
                <a16:creationId xmlns:a16="http://schemas.microsoft.com/office/drawing/2014/main" id="{65456227-73F4-4CF3-9ECC-08BA2F1D4FDE}"/>
              </a:ext>
            </a:extLst>
          </p:cNvPr>
          <p:cNvSpPr txBox="1"/>
          <p:nvPr/>
        </p:nvSpPr>
        <p:spPr>
          <a:xfrm rot="19359825">
            <a:off x="4473912" y="410630"/>
            <a:ext cx="901098" cy="257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i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glmS_</a:t>
            </a:r>
            <a:r>
              <a:rPr lang="en-US" sz="900" b="1" i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RJ1</a:t>
            </a:r>
            <a:endParaRPr sz="900" b="1" dirty="0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sp>
        <p:nvSpPr>
          <p:cNvPr id="103" name="Google Shape;163;p21">
            <a:extLst>
              <a:ext uri="{FF2B5EF4-FFF2-40B4-BE49-F238E27FC236}">
                <a16:creationId xmlns:a16="http://schemas.microsoft.com/office/drawing/2014/main" id="{1794A53B-11B5-46FE-B5E7-5E6B3AE33AD5}"/>
              </a:ext>
            </a:extLst>
          </p:cNvPr>
          <p:cNvSpPr txBox="1"/>
          <p:nvPr/>
        </p:nvSpPr>
        <p:spPr>
          <a:xfrm rot="19360505">
            <a:off x="4744478" y="470812"/>
            <a:ext cx="719207" cy="257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i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glmS_</a:t>
            </a:r>
            <a:r>
              <a:rPr lang="en-US" sz="900" b="1" i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33</a:t>
            </a:r>
            <a:endParaRPr sz="900" b="1" dirty="0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sp>
        <p:nvSpPr>
          <p:cNvPr id="104" name="Google Shape;164;p21">
            <a:extLst>
              <a:ext uri="{FF2B5EF4-FFF2-40B4-BE49-F238E27FC236}">
                <a16:creationId xmlns:a16="http://schemas.microsoft.com/office/drawing/2014/main" id="{EE7848C6-A60E-4250-8897-37B4D1F336F4}"/>
              </a:ext>
            </a:extLst>
          </p:cNvPr>
          <p:cNvSpPr txBox="1"/>
          <p:nvPr/>
        </p:nvSpPr>
        <p:spPr>
          <a:xfrm rot="19359825">
            <a:off x="4977205" y="449568"/>
            <a:ext cx="794172" cy="257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M9_</a:t>
            </a:r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RJ1</a:t>
            </a:r>
            <a:endParaRPr sz="900" b="1" dirty="0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sp>
        <p:nvSpPr>
          <p:cNvPr id="105" name="Google Shape;165;p21">
            <a:extLst>
              <a:ext uri="{FF2B5EF4-FFF2-40B4-BE49-F238E27FC236}">
                <a16:creationId xmlns:a16="http://schemas.microsoft.com/office/drawing/2014/main" id="{8C9A4FF1-D82B-460E-BF0D-9E6586EE638E}"/>
              </a:ext>
            </a:extLst>
          </p:cNvPr>
          <p:cNvSpPr txBox="1"/>
          <p:nvPr/>
        </p:nvSpPr>
        <p:spPr>
          <a:xfrm rot="19360505">
            <a:off x="5222245" y="472343"/>
            <a:ext cx="719207" cy="257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M9_</a:t>
            </a:r>
            <a:r>
              <a:rPr lang="en-US" sz="900" b="1" dirty="0" err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i</a:t>
            </a:r>
            <a:r>
              <a:rPr lang="en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33</a:t>
            </a:r>
            <a:endParaRPr sz="900" b="1" dirty="0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sp>
        <p:nvSpPr>
          <p:cNvPr id="106" name="Google Shape;166;p21">
            <a:extLst>
              <a:ext uri="{FF2B5EF4-FFF2-40B4-BE49-F238E27FC236}">
                <a16:creationId xmlns:a16="http://schemas.microsoft.com/office/drawing/2014/main" id="{474B55C3-3C98-4055-9E08-6C156D57A961}"/>
              </a:ext>
            </a:extLst>
          </p:cNvPr>
          <p:cNvSpPr txBox="1"/>
          <p:nvPr/>
        </p:nvSpPr>
        <p:spPr>
          <a:xfrm rot="19360734">
            <a:off x="5420165" y="427756"/>
            <a:ext cx="849640" cy="257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" sz="900" b="1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BL21(DE3)</a:t>
            </a:r>
            <a:endParaRPr sz="900" b="1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cxnSp>
        <p:nvCxnSpPr>
          <p:cNvPr id="107" name="Straight Arrow Connector 106">
            <a:extLst>
              <a:ext uri="{FF2B5EF4-FFF2-40B4-BE49-F238E27FC236}">
                <a16:creationId xmlns:a16="http://schemas.microsoft.com/office/drawing/2014/main" id="{95B5B3C9-CE9E-4A3A-9DC0-615B5DD608C7}"/>
              </a:ext>
            </a:extLst>
          </p:cNvPr>
          <p:cNvCxnSpPr>
            <a:cxnSpLocks/>
          </p:cNvCxnSpPr>
          <p:nvPr/>
        </p:nvCxnSpPr>
        <p:spPr>
          <a:xfrm flipH="1">
            <a:off x="555368" y="1823868"/>
            <a:ext cx="145930" cy="0"/>
          </a:xfrm>
          <a:prstGeom prst="straightConnector1">
            <a:avLst/>
          </a:prstGeom>
          <a:ln w="28575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Arrow Connector 107">
            <a:extLst>
              <a:ext uri="{FF2B5EF4-FFF2-40B4-BE49-F238E27FC236}">
                <a16:creationId xmlns:a16="http://schemas.microsoft.com/office/drawing/2014/main" id="{B2A32684-3423-4F09-9072-F472BB8FF781}"/>
              </a:ext>
            </a:extLst>
          </p:cNvPr>
          <p:cNvCxnSpPr>
            <a:cxnSpLocks/>
          </p:cNvCxnSpPr>
          <p:nvPr/>
        </p:nvCxnSpPr>
        <p:spPr>
          <a:xfrm flipH="1">
            <a:off x="557195" y="1932989"/>
            <a:ext cx="141079" cy="0"/>
          </a:xfrm>
          <a:prstGeom prst="straightConnector1">
            <a:avLst/>
          </a:prstGeom>
          <a:ln w="28575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TextBox 108">
            <a:extLst>
              <a:ext uri="{FF2B5EF4-FFF2-40B4-BE49-F238E27FC236}">
                <a16:creationId xmlns:a16="http://schemas.microsoft.com/office/drawing/2014/main" id="{4B78C030-3027-49C6-A543-9069AA660010}"/>
              </a:ext>
            </a:extLst>
          </p:cNvPr>
          <p:cNvSpPr txBox="1"/>
          <p:nvPr/>
        </p:nvSpPr>
        <p:spPr>
          <a:xfrm>
            <a:off x="-14263" y="1653672"/>
            <a:ext cx="59533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3.0 kb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D78890CD-0DC6-4924-B668-41260440726A}"/>
              </a:ext>
            </a:extLst>
          </p:cNvPr>
          <p:cNvSpPr txBox="1"/>
          <p:nvPr/>
        </p:nvSpPr>
        <p:spPr>
          <a:xfrm>
            <a:off x="-14261" y="1799894"/>
            <a:ext cx="5953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2.0 kb</a:t>
            </a:r>
          </a:p>
        </p:txBody>
      </p:sp>
      <p:cxnSp>
        <p:nvCxnSpPr>
          <p:cNvPr id="111" name="Straight Arrow Connector 110">
            <a:extLst>
              <a:ext uri="{FF2B5EF4-FFF2-40B4-BE49-F238E27FC236}">
                <a16:creationId xmlns:a16="http://schemas.microsoft.com/office/drawing/2014/main" id="{4F07F1EC-2828-4B65-9F8B-D713ACA155BE}"/>
              </a:ext>
            </a:extLst>
          </p:cNvPr>
          <p:cNvCxnSpPr>
            <a:cxnSpLocks/>
          </p:cNvCxnSpPr>
          <p:nvPr/>
        </p:nvCxnSpPr>
        <p:spPr>
          <a:xfrm flipH="1">
            <a:off x="3769055" y="1830238"/>
            <a:ext cx="145930" cy="0"/>
          </a:xfrm>
          <a:prstGeom prst="straightConnector1">
            <a:avLst/>
          </a:prstGeom>
          <a:ln w="28575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Arrow Connector 111">
            <a:extLst>
              <a:ext uri="{FF2B5EF4-FFF2-40B4-BE49-F238E27FC236}">
                <a16:creationId xmlns:a16="http://schemas.microsoft.com/office/drawing/2014/main" id="{01EB8DB2-7C87-4C41-B916-1708E6B8D82F}"/>
              </a:ext>
            </a:extLst>
          </p:cNvPr>
          <p:cNvCxnSpPr>
            <a:cxnSpLocks/>
          </p:cNvCxnSpPr>
          <p:nvPr/>
        </p:nvCxnSpPr>
        <p:spPr>
          <a:xfrm flipH="1">
            <a:off x="3769067" y="1939359"/>
            <a:ext cx="141079" cy="0"/>
          </a:xfrm>
          <a:prstGeom prst="straightConnector1">
            <a:avLst/>
          </a:prstGeom>
          <a:ln w="28575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TextBox 112">
            <a:extLst>
              <a:ext uri="{FF2B5EF4-FFF2-40B4-BE49-F238E27FC236}">
                <a16:creationId xmlns:a16="http://schemas.microsoft.com/office/drawing/2014/main" id="{873A2919-601E-4236-A69C-DACF8071F606}"/>
              </a:ext>
            </a:extLst>
          </p:cNvPr>
          <p:cNvSpPr txBox="1"/>
          <p:nvPr/>
        </p:nvSpPr>
        <p:spPr>
          <a:xfrm>
            <a:off x="3196766" y="1660043"/>
            <a:ext cx="59533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3.0 kb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DD8EF171-E252-49FC-8BED-2BAFCA0291C4}"/>
              </a:ext>
            </a:extLst>
          </p:cNvPr>
          <p:cNvSpPr txBox="1"/>
          <p:nvPr/>
        </p:nvSpPr>
        <p:spPr>
          <a:xfrm>
            <a:off x="3196776" y="1806265"/>
            <a:ext cx="59533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2.0 kb</a:t>
            </a:r>
          </a:p>
        </p:txBody>
      </p:sp>
      <p:cxnSp>
        <p:nvCxnSpPr>
          <p:cNvPr id="115" name="Straight Arrow Connector 114">
            <a:extLst>
              <a:ext uri="{FF2B5EF4-FFF2-40B4-BE49-F238E27FC236}">
                <a16:creationId xmlns:a16="http://schemas.microsoft.com/office/drawing/2014/main" id="{9D583C4D-D5F0-42AD-A268-0C08D03C69D9}"/>
              </a:ext>
            </a:extLst>
          </p:cNvPr>
          <p:cNvCxnSpPr>
            <a:cxnSpLocks/>
          </p:cNvCxnSpPr>
          <p:nvPr/>
        </p:nvCxnSpPr>
        <p:spPr>
          <a:xfrm flipH="1">
            <a:off x="3769055" y="2037671"/>
            <a:ext cx="145930" cy="0"/>
          </a:xfrm>
          <a:prstGeom prst="straightConnector1">
            <a:avLst/>
          </a:prstGeom>
          <a:ln w="28575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Arrow Connector 115">
            <a:extLst>
              <a:ext uri="{FF2B5EF4-FFF2-40B4-BE49-F238E27FC236}">
                <a16:creationId xmlns:a16="http://schemas.microsoft.com/office/drawing/2014/main" id="{94F29310-AD68-45C0-B8B5-CF29575A2C68}"/>
              </a:ext>
            </a:extLst>
          </p:cNvPr>
          <p:cNvCxnSpPr>
            <a:cxnSpLocks/>
          </p:cNvCxnSpPr>
          <p:nvPr/>
        </p:nvCxnSpPr>
        <p:spPr>
          <a:xfrm flipH="1">
            <a:off x="3769067" y="2159491"/>
            <a:ext cx="141079" cy="0"/>
          </a:xfrm>
          <a:prstGeom prst="straightConnector1">
            <a:avLst/>
          </a:prstGeom>
          <a:ln w="28575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TextBox 116">
            <a:extLst>
              <a:ext uri="{FF2B5EF4-FFF2-40B4-BE49-F238E27FC236}">
                <a16:creationId xmlns:a16="http://schemas.microsoft.com/office/drawing/2014/main" id="{51DD0665-0B82-4C61-BCCA-39FE65B06B5D}"/>
              </a:ext>
            </a:extLst>
          </p:cNvPr>
          <p:cNvSpPr txBox="1"/>
          <p:nvPr/>
        </p:nvSpPr>
        <p:spPr>
          <a:xfrm>
            <a:off x="3196766" y="1927904"/>
            <a:ext cx="59533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.5 kb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76EFCB45-2AEC-4D04-921C-A2DC0B2130A1}"/>
              </a:ext>
            </a:extLst>
          </p:cNvPr>
          <p:cNvSpPr txBox="1"/>
          <p:nvPr/>
        </p:nvSpPr>
        <p:spPr>
          <a:xfrm>
            <a:off x="3196776" y="2031919"/>
            <a:ext cx="59533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.0 kb</a:t>
            </a:r>
          </a:p>
        </p:txBody>
      </p:sp>
      <p:cxnSp>
        <p:nvCxnSpPr>
          <p:cNvPr id="119" name="Straight Arrow Connector 118">
            <a:extLst>
              <a:ext uri="{FF2B5EF4-FFF2-40B4-BE49-F238E27FC236}">
                <a16:creationId xmlns:a16="http://schemas.microsoft.com/office/drawing/2014/main" id="{9054DC83-680C-4C00-96EA-C37275669B7E}"/>
              </a:ext>
            </a:extLst>
          </p:cNvPr>
          <p:cNvCxnSpPr>
            <a:cxnSpLocks/>
          </p:cNvCxnSpPr>
          <p:nvPr/>
        </p:nvCxnSpPr>
        <p:spPr>
          <a:xfrm flipH="1">
            <a:off x="3769067" y="2248391"/>
            <a:ext cx="141079" cy="0"/>
          </a:xfrm>
          <a:prstGeom prst="straightConnector1">
            <a:avLst/>
          </a:prstGeom>
          <a:ln w="28575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TextBox 119">
            <a:extLst>
              <a:ext uri="{FF2B5EF4-FFF2-40B4-BE49-F238E27FC236}">
                <a16:creationId xmlns:a16="http://schemas.microsoft.com/office/drawing/2014/main" id="{C801367F-8E3E-43A8-BBC2-2EB2B583D907}"/>
              </a:ext>
            </a:extLst>
          </p:cNvPr>
          <p:cNvSpPr txBox="1"/>
          <p:nvPr/>
        </p:nvSpPr>
        <p:spPr>
          <a:xfrm>
            <a:off x="3196776" y="2144502"/>
            <a:ext cx="59533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0.7 kb</a:t>
            </a:r>
          </a:p>
        </p:txBody>
      </p:sp>
      <p:sp>
        <p:nvSpPr>
          <p:cNvPr id="121" name="Google Shape;167;p21">
            <a:extLst>
              <a:ext uri="{FF2B5EF4-FFF2-40B4-BE49-F238E27FC236}">
                <a16:creationId xmlns:a16="http://schemas.microsoft.com/office/drawing/2014/main" id="{5D6C9384-8F87-4637-B200-5CCACA475AD5}"/>
              </a:ext>
            </a:extLst>
          </p:cNvPr>
          <p:cNvSpPr txBox="1"/>
          <p:nvPr/>
        </p:nvSpPr>
        <p:spPr>
          <a:xfrm>
            <a:off x="665419" y="634474"/>
            <a:ext cx="286485" cy="2510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M</a:t>
            </a:r>
            <a:endParaRPr sz="900" b="1" dirty="0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sp>
        <p:nvSpPr>
          <p:cNvPr id="122" name="Google Shape;167;p21">
            <a:extLst>
              <a:ext uri="{FF2B5EF4-FFF2-40B4-BE49-F238E27FC236}">
                <a16:creationId xmlns:a16="http://schemas.microsoft.com/office/drawing/2014/main" id="{7BFEB760-C403-49BD-909A-23D62E35FD71}"/>
              </a:ext>
            </a:extLst>
          </p:cNvPr>
          <p:cNvSpPr txBox="1"/>
          <p:nvPr/>
        </p:nvSpPr>
        <p:spPr>
          <a:xfrm>
            <a:off x="3839605" y="606989"/>
            <a:ext cx="286485" cy="2510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9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M</a:t>
            </a:r>
            <a:endParaRPr sz="900" b="1" dirty="0"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5907375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435</Words>
  <Application>Microsoft Office PowerPoint</Application>
  <PresentationFormat>Custom</PresentationFormat>
  <Paragraphs>4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i Yada</dc:creator>
  <cp:lastModifiedBy>Ai Yada</cp:lastModifiedBy>
  <cp:revision>2</cp:revision>
  <dcterms:created xsi:type="dcterms:W3CDTF">2021-01-21T02:19:33Z</dcterms:created>
  <dcterms:modified xsi:type="dcterms:W3CDTF">2021-01-21T02:23:02Z</dcterms:modified>
</cp:coreProperties>
</file>